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A3BCD-ACA0-425B-8E70-480E216280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44B12-AD8E-40A4-A1FD-4F116AC473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0B7554-53DF-470F-AA8B-DBB434B266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F9D21-10AC-4F94-8E94-6FC6E78727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F7527-82CF-4865-9A97-4121C3157C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80B3B-1429-4963-BF2F-E6043A7F20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AC860-2B5D-4EC2-8A51-BB20BEEA29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CC5C8D-F3E5-40B7-90B4-33ABE66912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2D01E-4AA1-4534-B634-BD5C7495BD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55C9E-0E87-4A97-A5E8-FA5D221E7A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33E5B-1037-4B90-AAE5-534CF2AD74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58569E-DB24-4703-B353-EE3CFE54D1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DB2586-13B1-45A8-8A02-230B64D970F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03280" y="692280"/>
          <a:ext cx="6273720" cy="5587920"/>
        </p:xfrm>
        <a:graphic>
          <a:graphicData uri="http://schemas.openxmlformats.org/drawingml/2006/table">
            <a:tbl>
              <a:tblPr/>
              <a:tblGrid>
                <a:gridCol w="561960"/>
                <a:gridCol w="2297160"/>
                <a:gridCol w="2346480"/>
                <a:gridCol w="1068120"/>
              </a:tblGrid>
              <a:tr h="371520">
                <a:tc gridSpan="4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to map </a:t>
                      </a:r>
                      <a:r>
                        <a:rPr b="1" i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d</a:t>
                      </a: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deletion points on genomic DN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6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plicon siz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base pair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ACGGATGGAGTGAGTTC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CCCCAAGATGAGGATT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TGGGCATCGTCTTTTTC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TCTCCCACCCTTACCAG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TGAGAAAGCCCTTTGC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AGCCAAGAAACTGGAC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TGTAAGCGCTCCAGGAA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GGCCAATGCATTAAAG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CTGTCCCACTTATGCAC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TCCTTGGCCTTTTTCTT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ACACGTTTATGCCATCA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CTAGGCAGGCAACAGA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CTCCACTCTTCCTTCC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TTTTTGGGTTGACAAT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ATGCCAGAGCCTATATT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AGCCTCATTCACAAGCAA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CATTGTTGCTTGTGAA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CTCCATTGGCTTTGTC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TCAGTCCCACTGCCACT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ACCAGTGGGAGGAAGAA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GGTGACAATGGGTATCC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GCAAGCTCTTGGGAAA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AAATGGGCCAATGAAGA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CCCTCACTGCCTATCAT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TAGACGGTGGAAGTCA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CTTGTCTTCTTGCTTT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2"/>
          <p:cNvSpPr/>
          <p:nvPr/>
        </p:nvSpPr>
        <p:spPr>
          <a:xfrm>
            <a:off x="487440" y="189000"/>
            <a:ext cx="624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3: mapping bsd dele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3"/>
          <p:cNvSpPr/>
          <p:nvPr/>
        </p:nvSpPr>
        <p:spPr>
          <a:xfrm>
            <a:off x="7812000" y="6093000"/>
            <a:ext cx="108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1/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1332000" y="692280"/>
          <a:ext cx="6640560" cy="5587920"/>
        </p:xfrm>
        <a:graphic>
          <a:graphicData uri="http://schemas.openxmlformats.org/drawingml/2006/table">
            <a:tbl>
              <a:tblPr/>
              <a:tblGrid>
                <a:gridCol w="828720"/>
                <a:gridCol w="2409840"/>
                <a:gridCol w="2333520"/>
                <a:gridCol w="1068480"/>
              </a:tblGrid>
              <a:tr h="371520">
                <a:tc gridSpan="4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to map </a:t>
                      </a:r>
                      <a:r>
                        <a:rPr b="1" i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d</a:t>
                      </a: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deletion points on genomic DN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8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plicon siz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base pair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GTGAATGGGATGAGCTA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TTGTGGGATAGCCACAT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ACATGTGGGAAAAGTGG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AGGACCTGAAGGGGTTA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AAATGTTGCCTCCTTT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GGCTGTGCTGAGTAAGA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AGCCTCAAGGACAGAGA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CAGCACAGTTGACGAA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TCTGCCTTGAGGACTCT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ACACAGGCTGGAAGAA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TCTGCTCACTCGAGAA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GTCTGTTGGCACAGAG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TAGCTGGAGAGCGTTG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TACGTTGGCATGGCTTT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TGGCAGGCTTTCTTCAC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GGGTTTGTCGTTTCAC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CTAAAGCGAGGGCTTC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CTGCCTTGTGTCTTCT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CTGTTTAGAGCGGCAG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CCAGAGAAGCCTGAGA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TCTGGCTGAGAACTGT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CTGGACTTTGACTTTCT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TGGATGAACTCTGCCA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CGTGTTTCAACTCTTT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2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GGGAAAGAAAGGCTTC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ATTGGGGATGTTTTGC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5" name="TextBox 2"/>
          <p:cNvSpPr/>
          <p:nvPr/>
        </p:nvSpPr>
        <p:spPr>
          <a:xfrm>
            <a:off x="7812000" y="6093000"/>
            <a:ext cx="108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2/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"/>
          <p:cNvGraphicFramePr/>
          <p:nvPr/>
        </p:nvGraphicFramePr>
        <p:xfrm>
          <a:off x="1547640" y="692280"/>
          <a:ext cx="6553440" cy="5587920"/>
        </p:xfrm>
        <a:graphic>
          <a:graphicData uri="http://schemas.openxmlformats.org/drawingml/2006/table">
            <a:tbl>
              <a:tblPr/>
              <a:tblGrid>
                <a:gridCol w="828720"/>
                <a:gridCol w="2289240"/>
                <a:gridCol w="2365560"/>
                <a:gridCol w="1069920"/>
              </a:tblGrid>
              <a:tr h="371520">
                <a:tc gridSpan="4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to map </a:t>
                      </a:r>
                      <a:r>
                        <a:rPr b="1" i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d</a:t>
                      </a: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deletion points on genomic DN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8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plicon siz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base pair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AGCTAGCCAGCACAAC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AAGGCCCAGGATTAAA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TCCAAAGTGCTTGGCTC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GGGGGTAGATTGTGGA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TATCCCAGCAAAGCAAA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TATTGAGCCCCTCTG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ACGGCTCACTGAAACT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CTGCACAGCCTCCCATA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TAACCATGGGGGACACA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CTGCACCTTACTCCCT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CCTGACTGAGCCTTCT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GGGGCTATAGGAGCTC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GGAGCAGGGATTTAAGG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GACCTAGGTTTGGGGTG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GCTGAACAGACCAACCA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GAAAATTGCCTGGAATCA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AGGTGGCATTCTCGATT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ACAAACACTGGGTGGAA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TCTGAAGGCAGGCTGT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CTGAAAGGACCCAGATAG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TATGGGGACGTTGCTGTG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ATATCCGGGGATCC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TGGATCCCCGGATA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AGAGGACAGAGCCAGCAG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2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CAGGAGAGAAATTGAT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ATGCCTTGATCTGCAC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7" name="TextBox 2"/>
          <p:cNvSpPr/>
          <p:nvPr/>
        </p:nvSpPr>
        <p:spPr>
          <a:xfrm>
            <a:off x="8064360" y="6093000"/>
            <a:ext cx="107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3/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476360" y="692280"/>
          <a:ext cx="6602400" cy="3363840"/>
        </p:xfrm>
        <a:graphic>
          <a:graphicData uri="http://schemas.openxmlformats.org/drawingml/2006/table">
            <a:tbl>
              <a:tblPr/>
              <a:tblGrid>
                <a:gridCol w="828720"/>
                <a:gridCol w="2295360"/>
                <a:gridCol w="2409840"/>
                <a:gridCol w="1068480"/>
              </a:tblGrid>
              <a:tr h="371520">
                <a:tc gridSpan="4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to map </a:t>
                      </a:r>
                      <a:r>
                        <a:rPr b="1" i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d</a:t>
                      </a: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deletion points on genomic DN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8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plicon siz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base pair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GGGTGGTATTGTTGTTC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GCCATGCTAACAGACCT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AGAGGGCTTGTCATTT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CGGCGATTTATCTAAGTT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TGAGAGATGGGCAAAGA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CCTACCGGTCAGAAATG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ACTCCAGAATGCATGAA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TCTCTGTTCCTTGGGTG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CACAGCCAGTGAGGTGAC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ATTTCTGGAATGGGTGG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TGGAGACAGCTGGCACAT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AAAGGAGGCTGAGGTAG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GAGCGAGACACAAGGAGA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ATGCGCAGAAGACAACA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TextBox 2"/>
          <p:cNvSpPr/>
          <p:nvPr/>
        </p:nvSpPr>
        <p:spPr>
          <a:xfrm>
            <a:off x="7812000" y="6093000"/>
            <a:ext cx="108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4/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12T13:29:16Z</dcterms:created>
  <dc:creator>bl2</dc:creator>
  <dc:description/>
  <dc:language>en-US</dc:language>
  <cp:lastModifiedBy>bl2</cp:lastModifiedBy>
  <dcterms:modified xsi:type="dcterms:W3CDTF">2012-07-12T13:29:47Z</dcterms:modified>
  <cp:revision>1</cp:revision>
  <dc:subject/>
  <dc:title>PowerPoint Presentation</dc:title>
</cp:coreProperties>
</file>